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3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7224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3037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6541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4224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4746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1281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7233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01656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0622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89749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4082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89AD0-AF77-4596-9D5D-6B9881E82156}" type="datetimeFigureOut">
              <a:rPr lang="en-CA" smtClean="0"/>
              <a:t>2019-07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4C72B-5529-4D0E-AE0F-4D89280B8BF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28525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5975" y="5116988"/>
            <a:ext cx="83033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5 most relatively abundant phyla in the nasopharyngeal microbiota of individual steers th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transported and commingled at an auction market for 48 h before transportation to the feedlot (n = 13)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x-axis indicates unique animal identifiers.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974" y="1927552"/>
            <a:ext cx="8595360" cy="2739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1480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4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edle plot of Spearman correlations</dc:title>
  <dc:creator>Schwinghamer, Timothy</dc:creator>
  <cp:lastModifiedBy>Saimaiti, Amaiti</cp:lastModifiedBy>
  <cp:revision>4</cp:revision>
  <dcterms:created xsi:type="dcterms:W3CDTF">2019-05-03T19:29:08Z</dcterms:created>
  <dcterms:modified xsi:type="dcterms:W3CDTF">2019-07-27T02:04:20Z</dcterms:modified>
</cp:coreProperties>
</file>